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264275" cy="8423275"/>
  <p:notesSz cx="6858000" cy="9144000"/>
  <p:defaultTextStyle>
    <a:defPPr>
      <a:defRPr lang="en-US"/>
    </a:defPPr>
    <a:lvl1pPr marL="0" algn="l" defTabSz="801106" rtl="0" eaLnBrk="1" latinLnBrk="0" hangingPunct="1">
      <a:defRPr sz="1577" kern="1200">
        <a:solidFill>
          <a:schemeClr val="tx1"/>
        </a:solidFill>
        <a:latin typeface="+mn-lt"/>
        <a:ea typeface="+mn-ea"/>
        <a:cs typeface="+mn-cs"/>
      </a:defRPr>
    </a:lvl1pPr>
    <a:lvl2pPr marL="400553" algn="l" defTabSz="801106" rtl="0" eaLnBrk="1" latinLnBrk="0" hangingPunct="1">
      <a:defRPr sz="1577" kern="1200">
        <a:solidFill>
          <a:schemeClr val="tx1"/>
        </a:solidFill>
        <a:latin typeface="+mn-lt"/>
        <a:ea typeface="+mn-ea"/>
        <a:cs typeface="+mn-cs"/>
      </a:defRPr>
    </a:lvl2pPr>
    <a:lvl3pPr marL="801106" algn="l" defTabSz="801106" rtl="0" eaLnBrk="1" latinLnBrk="0" hangingPunct="1">
      <a:defRPr sz="1577" kern="1200">
        <a:solidFill>
          <a:schemeClr val="tx1"/>
        </a:solidFill>
        <a:latin typeface="+mn-lt"/>
        <a:ea typeface="+mn-ea"/>
        <a:cs typeface="+mn-cs"/>
      </a:defRPr>
    </a:lvl3pPr>
    <a:lvl4pPr marL="1201659" algn="l" defTabSz="801106" rtl="0" eaLnBrk="1" latinLnBrk="0" hangingPunct="1">
      <a:defRPr sz="1577" kern="1200">
        <a:solidFill>
          <a:schemeClr val="tx1"/>
        </a:solidFill>
        <a:latin typeface="+mn-lt"/>
        <a:ea typeface="+mn-ea"/>
        <a:cs typeface="+mn-cs"/>
      </a:defRPr>
    </a:lvl4pPr>
    <a:lvl5pPr marL="1602212" algn="l" defTabSz="801106" rtl="0" eaLnBrk="1" latinLnBrk="0" hangingPunct="1">
      <a:defRPr sz="1577" kern="1200">
        <a:solidFill>
          <a:schemeClr val="tx1"/>
        </a:solidFill>
        <a:latin typeface="+mn-lt"/>
        <a:ea typeface="+mn-ea"/>
        <a:cs typeface="+mn-cs"/>
      </a:defRPr>
    </a:lvl5pPr>
    <a:lvl6pPr marL="2002765" algn="l" defTabSz="801106" rtl="0" eaLnBrk="1" latinLnBrk="0" hangingPunct="1">
      <a:defRPr sz="1577" kern="1200">
        <a:solidFill>
          <a:schemeClr val="tx1"/>
        </a:solidFill>
        <a:latin typeface="+mn-lt"/>
        <a:ea typeface="+mn-ea"/>
        <a:cs typeface="+mn-cs"/>
      </a:defRPr>
    </a:lvl6pPr>
    <a:lvl7pPr marL="2403318" algn="l" defTabSz="801106" rtl="0" eaLnBrk="1" latinLnBrk="0" hangingPunct="1">
      <a:defRPr sz="1577" kern="1200">
        <a:solidFill>
          <a:schemeClr val="tx1"/>
        </a:solidFill>
        <a:latin typeface="+mn-lt"/>
        <a:ea typeface="+mn-ea"/>
        <a:cs typeface="+mn-cs"/>
      </a:defRPr>
    </a:lvl7pPr>
    <a:lvl8pPr marL="2803870" algn="l" defTabSz="801106" rtl="0" eaLnBrk="1" latinLnBrk="0" hangingPunct="1">
      <a:defRPr sz="1577" kern="1200">
        <a:solidFill>
          <a:schemeClr val="tx1"/>
        </a:solidFill>
        <a:latin typeface="+mn-lt"/>
        <a:ea typeface="+mn-ea"/>
        <a:cs typeface="+mn-cs"/>
      </a:defRPr>
    </a:lvl8pPr>
    <a:lvl9pPr marL="3204423" algn="l" defTabSz="801106" rtl="0" eaLnBrk="1" latinLnBrk="0" hangingPunct="1">
      <a:defRPr sz="1577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42" userDrawn="1">
          <p15:clr>
            <a:srgbClr val="A4A3A4"/>
          </p15:clr>
        </p15:guide>
        <p15:guide id="2" pos="174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 showGuides="1">
      <p:cViewPr varScale="1">
        <p:scale>
          <a:sx n="79" d="100"/>
          <a:sy n="79" d="100"/>
        </p:scale>
        <p:origin x="2098" y="120"/>
      </p:cViewPr>
      <p:guideLst>
        <p:guide orient="horz" pos="242"/>
        <p:guide pos="174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69821" y="1378532"/>
            <a:ext cx="5324634" cy="2932548"/>
          </a:xfrm>
        </p:spPr>
        <p:txBody>
          <a:bodyPr anchor="b"/>
          <a:lstStyle>
            <a:lvl1pPr algn="ctr">
              <a:defRPr sz="4111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83035" y="4424170"/>
            <a:ext cx="4698206" cy="2033674"/>
          </a:xfrm>
        </p:spPr>
        <p:txBody>
          <a:bodyPr/>
          <a:lstStyle>
            <a:lvl1pPr marL="0" indent="0" algn="ctr">
              <a:buNone/>
              <a:defRPr sz="1644"/>
            </a:lvl1pPr>
            <a:lvl2pPr marL="313228" indent="0" algn="ctr">
              <a:buNone/>
              <a:defRPr sz="1370"/>
            </a:lvl2pPr>
            <a:lvl3pPr marL="626455" indent="0" algn="ctr">
              <a:buNone/>
              <a:defRPr sz="1233"/>
            </a:lvl3pPr>
            <a:lvl4pPr marL="939683" indent="0" algn="ctr">
              <a:buNone/>
              <a:defRPr sz="1096"/>
            </a:lvl4pPr>
            <a:lvl5pPr marL="1252911" indent="0" algn="ctr">
              <a:buNone/>
              <a:defRPr sz="1096"/>
            </a:lvl5pPr>
            <a:lvl6pPr marL="1566139" indent="0" algn="ctr">
              <a:buNone/>
              <a:defRPr sz="1096"/>
            </a:lvl6pPr>
            <a:lvl7pPr marL="1879366" indent="0" algn="ctr">
              <a:buNone/>
              <a:defRPr sz="1096"/>
            </a:lvl7pPr>
            <a:lvl8pPr marL="2192594" indent="0" algn="ctr">
              <a:buNone/>
              <a:defRPr sz="1096"/>
            </a:lvl8pPr>
            <a:lvl9pPr marL="2505822" indent="0" algn="ctr">
              <a:buNone/>
              <a:defRPr sz="1096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E6112-60D8-4E08-9D1D-6C513A847DDB}" type="datetimeFigureOut">
              <a:rPr lang="en-AU" smtClean="0"/>
              <a:t>15/09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910109-5C1F-4E17-A5EA-EDC54C31656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44020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E6112-60D8-4E08-9D1D-6C513A847DDB}" type="datetimeFigureOut">
              <a:rPr lang="en-AU" smtClean="0"/>
              <a:t>15/09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910109-5C1F-4E17-A5EA-EDC54C31656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103390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482872" y="448462"/>
            <a:ext cx="1350734" cy="713833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30669" y="448462"/>
            <a:ext cx="3973899" cy="713833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E6112-60D8-4E08-9D1D-6C513A847DDB}" type="datetimeFigureOut">
              <a:rPr lang="en-AU" smtClean="0"/>
              <a:t>15/09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910109-5C1F-4E17-A5EA-EDC54C31656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154487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E6112-60D8-4E08-9D1D-6C513A847DDB}" type="datetimeFigureOut">
              <a:rPr lang="en-AU" smtClean="0"/>
              <a:t>15/09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910109-5C1F-4E17-A5EA-EDC54C31656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23518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7407" y="2099972"/>
            <a:ext cx="5402937" cy="3503848"/>
          </a:xfrm>
        </p:spPr>
        <p:txBody>
          <a:bodyPr anchor="b"/>
          <a:lstStyle>
            <a:lvl1pPr>
              <a:defRPr sz="4111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7407" y="5636967"/>
            <a:ext cx="5402937" cy="1842591"/>
          </a:xfrm>
        </p:spPr>
        <p:txBody>
          <a:bodyPr/>
          <a:lstStyle>
            <a:lvl1pPr marL="0" indent="0">
              <a:buNone/>
              <a:defRPr sz="1644">
                <a:solidFill>
                  <a:schemeClr val="tx1"/>
                </a:solidFill>
              </a:defRPr>
            </a:lvl1pPr>
            <a:lvl2pPr marL="313228" indent="0">
              <a:buNone/>
              <a:defRPr sz="1370">
                <a:solidFill>
                  <a:schemeClr val="tx1">
                    <a:tint val="75000"/>
                  </a:schemeClr>
                </a:solidFill>
              </a:defRPr>
            </a:lvl2pPr>
            <a:lvl3pPr marL="626455" indent="0">
              <a:buNone/>
              <a:defRPr sz="1233">
                <a:solidFill>
                  <a:schemeClr val="tx1">
                    <a:tint val="75000"/>
                  </a:schemeClr>
                </a:solidFill>
              </a:defRPr>
            </a:lvl3pPr>
            <a:lvl4pPr marL="939683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4pPr>
            <a:lvl5pPr marL="1252911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5pPr>
            <a:lvl6pPr marL="1566139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6pPr>
            <a:lvl7pPr marL="1879366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7pPr>
            <a:lvl8pPr marL="2192594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8pPr>
            <a:lvl9pPr marL="2505822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E6112-60D8-4E08-9D1D-6C513A847DDB}" type="datetimeFigureOut">
              <a:rPr lang="en-AU" smtClean="0"/>
              <a:t>15/09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910109-5C1F-4E17-A5EA-EDC54C31656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563528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30669" y="2242307"/>
            <a:ext cx="2662317" cy="5344491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71289" y="2242307"/>
            <a:ext cx="2662317" cy="5344491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E6112-60D8-4E08-9D1D-6C513A847DDB}" type="datetimeFigureOut">
              <a:rPr lang="en-AU" smtClean="0"/>
              <a:t>15/09/2018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910109-5C1F-4E17-A5EA-EDC54C31656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204609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1485" y="448463"/>
            <a:ext cx="5402937" cy="162811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1485" y="2064873"/>
            <a:ext cx="2650082" cy="1011962"/>
          </a:xfrm>
        </p:spPr>
        <p:txBody>
          <a:bodyPr anchor="b"/>
          <a:lstStyle>
            <a:lvl1pPr marL="0" indent="0">
              <a:buNone/>
              <a:defRPr sz="1644" b="1"/>
            </a:lvl1pPr>
            <a:lvl2pPr marL="313228" indent="0">
              <a:buNone/>
              <a:defRPr sz="1370" b="1"/>
            </a:lvl2pPr>
            <a:lvl3pPr marL="626455" indent="0">
              <a:buNone/>
              <a:defRPr sz="1233" b="1"/>
            </a:lvl3pPr>
            <a:lvl4pPr marL="939683" indent="0">
              <a:buNone/>
              <a:defRPr sz="1096" b="1"/>
            </a:lvl4pPr>
            <a:lvl5pPr marL="1252911" indent="0">
              <a:buNone/>
              <a:defRPr sz="1096" b="1"/>
            </a:lvl5pPr>
            <a:lvl6pPr marL="1566139" indent="0">
              <a:buNone/>
              <a:defRPr sz="1096" b="1"/>
            </a:lvl6pPr>
            <a:lvl7pPr marL="1879366" indent="0">
              <a:buNone/>
              <a:defRPr sz="1096" b="1"/>
            </a:lvl7pPr>
            <a:lvl8pPr marL="2192594" indent="0">
              <a:buNone/>
              <a:defRPr sz="1096" b="1"/>
            </a:lvl8pPr>
            <a:lvl9pPr marL="2505822" indent="0">
              <a:buNone/>
              <a:defRPr sz="1096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1485" y="3076835"/>
            <a:ext cx="2650082" cy="4525561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71289" y="2064873"/>
            <a:ext cx="2663133" cy="1011962"/>
          </a:xfrm>
        </p:spPr>
        <p:txBody>
          <a:bodyPr anchor="b"/>
          <a:lstStyle>
            <a:lvl1pPr marL="0" indent="0">
              <a:buNone/>
              <a:defRPr sz="1644" b="1"/>
            </a:lvl1pPr>
            <a:lvl2pPr marL="313228" indent="0">
              <a:buNone/>
              <a:defRPr sz="1370" b="1"/>
            </a:lvl2pPr>
            <a:lvl3pPr marL="626455" indent="0">
              <a:buNone/>
              <a:defRPr sz="1233" b="1"/>
            </a:lvl3pPr>
            <a:lvl4pPr marL="939683" indent="0">
              <a:buNone/>
              <a:defRPr sz="1096" b="1"/>
            </a:lvl4pPr>
            <a:lvl5pPr marL="1252911" indent="0">
              <a:buNone/>
              <a:defRPr sz="1096" b="1"/>
            </a:lvl5pPr>
            <a:lvl6pPr marL="1566139" indent="0">
              <a:buNone/>
              <a:defRPr sz="1096" b="1"/>
            </a:lvl6pPr>
            <a:lvl7pPr marL="1879366" indent="0">
              <a:buNone/>
              <a:defRPr sz="1096" b="1"/>
            </a:lvl7pPr>
            <a:lvl8pPr marL="2192594" indent="0">
              <a:buNone/>
              <a:defRPr sz="1096" b="1"/>
            </a:lvl8pPr>
            <a:lvl9pPr marL="2505822" indent="0">
              <a:buNone/>
              <a:defRPr sz="1096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71289" y="3076835"/>
            <a:ext cx="2663133" cy="4525561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E6112-60D8-4E08-9D1D-6C513A847DDB}" type="datetimeFigureOut">
              <a:rPr lang="en-AU" smtClean="0"/>
              <a:t>15/09/2018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910109-5C1F-4E17-A5EA-EDC54C31656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208557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E6112-60D8-4E08-9D1D-6C513A847DDB}" type="datetimeFigureOut">
              <a:rPr lang="en-AU" smtClean="0"/>
              <a:t>15/09/2018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910109-5C1F-4E17-A5EA-EDC54C31656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978452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E6112-60D8-4E08-9D1D-6C513A847DDB}" type="datetimeFigureOut">
              <a:rPr lang="en-AU" smtClean="0"/>
              <a:t>15/09/2018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910109-5C1F-4E17-A5EA-EDC54C31656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175912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1485" y="561552"/>
            <a:ext cx="2020392" cy="1965431"/>
          </a:xfrm>
        </p:spPr>
        <p:txBody>
          <a:bodyPr anchor="b"/>
          <a:lstStyle>
            <a:lvl1pPr>
              <a:defRPr sz="2192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63133" y="1212797"/>
            <a:ext cx="3171289" cy="5985985"/>
          </a:xfrm>
        </p:spPr>
        <p:txBody>
          <a:bodyPr/>
          <a:lstStyle>
            <a:lvl1pPr>
              <a:defRPr sz="2192"/>
            </a:lvl1pPr>
            <a:lvl2pPr>
              <a:defRPr sz="1918"/>
            </a:lvl2pPr>
            <a:lvl3pPr>
              <a:defRPr sz="1644"/>
            </a:lvl3pPr>
            <a:lvl4pPr>
              <a:defRPr sz="1370"/>
            </a:lvl4pPr>
            <a:lvl5pPr>
              <a:defRPr sz="1370"/>
            </a:lvl5pPr>
            <a:lvl6pPr>
              <a:defRPr sz="1370"/>
            </a:lvl6pPr>
            <a:lvl7pPr>
              <a:defRPr sz="1370"/>
            </a:lvl7pPr>
            <a:lvl8pPr>
              <a:defRPr sz="1370"/>
            </a:lvl8pPr>
            <a:lvl9pPr>
              <a:defRPr sz="137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1485" y="2526982"/>
            <a:ext cx="2020392" cy="4681548"/>
          </a:xfrm>
        </p:spPr>
        <p:txBody>
          <a:bodyPr/>
          <a:lstStyle>
            <a:lvl1pPr marL="0" indent="0">
              <a:buNone/>
              <a:defRPr sz="1096"/>
            </a:lvl1pPr>
            <a:lvl2pPr marL="313228" indent="0">
              <a:buNone/>
              <a:defRPr sz="959"/>
            </a:lvl2pPr>
            <a:lvl3pPr marL="626455" indent="0">
              <a:buNone/>
              <a:defRPr sz="822"/>
            </a:lvl3pPr>
            <a:lvl4pPr marL="939683" indent="0">
              <a:buNone/>
              <a:defRPr sz="685"/>
            </a:lvl4pPr>
            <a:lvl5pPr marL="1252911" indent="0">
              <a:buNone/>
              <a:defRPr sz="685"/>
            </a:lvl5pPr>
            <a:lvl6pPr marL="1566139" indent="0">
              <a:buNone/>
              <a:defRPr sz="685"/>
            </a:lvl6pPr>
            <a:lvl7pPr marL="1879366" indent="0">
              <a:buNone/>
              <a:defRPr sz="685"/>
            </a:lvl7pPr>
            <a:lvl8pPr marL="2192594" indent="0">
              <a:buNone/>
              <a:defRPr sz="685"/>
            </a:lvl8pPr>
            <a:lvl9pPr marL="2505822" indent="0">
              <a:buNone/>
              <a:defRPr sz="685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E6112-60D8-4E08-9D1D-6C513A847DDB}" type="datetimeFigureOut">
              <a:rPr lang="en-AU" smtClean="0"/>
              <a:t>15/09/2018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910109-5C1F-4E17-A5EA-EDC54C31656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585178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1485" y="561552"/>
            <a:ext cx="2020392" cy="1965431"/>
          </a:xfrm>
        </p:spPr>
        <p:txBody>
          <a:bodyPr anchor="b"/>
          <a:lstStyle>
            <a:lvl1pPr>
              <a:defRPr sz="2192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63133" y="1212797"/>
            <a:ext cx="3171289" cy="5985985"/>
          </a:xfrm>
        </p:spPr>
        <p:txBody>
          <a:bodyPr anchor="t"/>
          <a:lstStyle>
            <a:lvl1pPr marL="0" indent="0">
              <a:buNone/>
              <a:defRPr sz="2192"/>
            </a:lvl1pPr>
            <a:lvl2pPr marL="313228" indent="0">
              <a:buNone/>
              <a:defRPr sz="1918"/>
            </a:lvl2pPr>
            <a:lvl3pPr marL="626455" indent="0">
              <a:buNone/>
              <a:defRPr sz="1644"/>
            </a:lvl3pPr>
            <a:lvl4pPr marL="939683" indent="0">
              <a:buNone/>
              <a:defRPr sz="1370"/>
            </a:lvl4pPr>
            <a:lvl5pPr marL="1252911" indent="0">
              <a:buNone/>
              <a:defRPr sz="1370"/>
            </a:lvl5pPr>
            <a:lvl6pPr marL="1566139" indent="0">
              <a:buNone/>
              <a:defRPr sz="1370"/>
            </a:lvl6pPr>
            <a:lvl7pPr marL="1879366" indent="0">
              <a:buNone/>
              <a:defRPr sz="1370"/>
            </a:lvl7pPr>
            <a:lvl8pPr marL="2192594" indent="0">
              <a:buNone/>
              <a:defRPr sz="1370"/>
            </a:lvl8pPr>
            <a:lvl9pPr marL="2505822" indent="0">
              <a:buNone/>
              <a:defRPr sz="137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1485" y="2526982"/>
            <a:ext cx="2020392" cy="4681548"/>
          </a:xfrm>
        </p:spPr>
        <p:txBody>
          <a:bodyPr/>
          <a:lstStyle>
            <a:lvl1pPr marL="0" indent="0">
              <a:buNone/>
              <a:defRPr sz="1096"/>
            </a:lvl1pPr>
            <a:lvl2pPr marL="313228" indent="0">
              <a:buNone/>
              <a:defRPr sz="959"/>
            </a:lvl2pPr>
            <a:lvl3pPr marL="626455" indent="0">
              <a:buNone/>
              <a:defRPr sz="822"/>
            </a:lvl3pPr>
            <a:lvl4pPr marL="939683" indent="0">
              <a:buNone/>
              <a:defRPr sz="685"/>
            </a:lvl4pPr>
            <a:lvl5pPr marL="1252911" indent="0">
              <a:buNone/>
              <a:defRPr sz="685"/>
            </a:lvl5pPr>
            <a:lvl6pPr marL="1566139" indent="0">
              <a:buNone/>
              <a:defRPr sz="685"/>
            </a:lvl6pPr>
            <a:lvl7pPr marL="1879366" indent="0">
              <a:buNone/>
              <a:defRPr sz="685"/>
            </a:lvl7pPr>
            <a:lvl8pPr marL="2192594" indent="0">
              <a:buNone/>
              <a:defRPr sz="685"/>
            </a:lvl8pPr>
            <a:lvl9pPr marL="2505822" indent="0">
              <a:buNone/>
              <a:defRPr sz="685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E6112-60D8-4E08-9D1D-6C513A847DDB}" type="datetimeFigureOut">
              <a:rPr lang="en-AU" smtClean="0"/>
              <a:t>15/09/2018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910109-5C1F-4E17-A5EA-EDC54C31656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103557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30669" y="448463"/>
            <a:ext cx="5402937" cy="162811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0669" y="2242307"/>
            <a:ext cx="5402937" cy="534449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30669" y="7807130"/>
            <a:ext cx="1409462" cy="448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0E6112-60D8-4E08-9D1D-6C513A847DDB}" type="datetimeFigureOut">
              <a:rPr lang="en-AU" smtClean="0"/>
              <a:t>15/09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75041" y="7807130"/>
            <a:ext cx="2114193" cy="448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424144" y="7807130"/>
            <a:ext cx="1409462" cy="448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910109-5C1F-4E17-A5EA-EDC54C31656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484646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26455" rtl="0" eaLnBrk="1" latinLnBrk="0" hangingPunct="1">
        <a:lnSpc>
          <a:spcPct val="90000"/>
        </a:lnSpc>
        <a:spcBef>
          <a:spcPct val="0"/>
        </a:spcBef>
        <a:buNone/>
        <a:defRPr sz="301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6614" indent="-156614" algn="l" defTabSz="626455" rtl="0" eaLnBrk="1" latinLnBrk="0" hangingPunct="1">
        <a:lnSpc>
          <a:spcPct val="90000"/>
        </a:lnSpc>
        <a:spcBef>
          <a:spcPts val="685"/>
        </a:spcBef>
        <a:buFont typeface="Arial" panose="020B0604020202020204" pitchFamily="34" charset="0"/>
        <a:buChar char="•"/>
        <a:defRPr sz="1918" kern="1200">
          <a:solidFill>
            <a:schemeClr val="tx1"/>
          </a:solidFill>
          <a:latin typeface="+mn-lt"/>
          <a:ea typeface="+mn-ea"/>
          <a:cs typeface="+mn-cs"/>
        </a:defRPr>
      </a:lvl1pPr>
      <a:lvl2pPr marL="469842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644" kern="1200">
          <a:solidFill>
            <a:schemeClr val="tx1"/>
          </a:solidFill>
          <a:latin typeface="+mn-lt"/>
          <a:ea typeface="+mn-ea"/>
          <a:cs typeface="+mn-cs"/>
        </a:defRPr>
      </a:lvl2pPr>
      <a:lvl3pPr marL="783069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370" kern="1200">
          <a:solidFill>
            <a:schemeClr val="tx1"/>
          </a:solidFill>
          <a:latin typeface="+mn-lt"/>
          <a:ea typeface="+mn-ea"/>
          <a:cs typeface="+mn-cs"/>
        </a:defRPr>
      </a:lvl3pPr>
      <a:lvl4pPr marL="1096297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4pPr>
      <a:lvl5pPr marL="1409525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5pPr>
      <a:lvl6pPr marL="1722752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6pPr>
      <a:lvl7pPr marL="2035980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7pPr>
      <a:lvl8pPr marL="2349208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8pPr>
      <a:lvl9pPr marL="2662436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1pPr>
      <a:lvl2pPr marL="313228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2pPr>
      <a:lvl3pPr marL="626455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3pPr>
      <a:lvl4pPr marL="939683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4pPr>
      <a:lvl5pPr marL="1252911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5pPr>
      <a:lvl6pPr marL="1566139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6pPr>
      <a:lvl7pPr marL="1879366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7pPr>
      <a:lvl8pPr marL="2192594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8pPr>
      <a:lvl9pPr marL="2505822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510209" y="72806"/>
            <a:ext cx="5295337" cy="8152004"/>
            <a:chOff x="510209" y="72806"/>
            <a:chExt cx="5295337" cy="8152004"/>
          </a:xfrm>
        </p:grpSpPr>
        <p:sp>
          <p:nvSpPr>
            <p:cNvPr id="47" name="Rectangle 46"/>
            <p:cNvSpPr/>
            <p:nvPr/>
          </p:nvSpPr>
          <p:spPr>
            <a:xfrm>
              <a:off x="2631400" y="72806"/>
              <a:ext cx="2216084" cy="19319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 sz="1341" dirty="0"/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510209" y="7243003"/>
              <a:ext cx="5295337" cy="9818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en-AU" sz="68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AU" sz="1020" b="1" dirty="0">
                  <a:latin typeface="Arial" panose="020B0604020202020204" pitchFamily="34" charset="0"/>
                  <a:cs typeface="Arial" panose="020B0604020202020204" pitchFamily="34" charset="0"/>
                </a:rPr>
                <a:t>Online Resource </a:t>
              </a:r>
              <a:r>
                <a:rPr lang="en-AU" sz="1020" b="1" dirty="0"/>
                <a:t>8</a:t>
              </a:r>
              <a:r>
                <a:rPr lang="en-AU" sz="1020" b="1" dirty="0" smtClean="0"/>
                <a:t> </a:t>
              </a:r>
              <a:r>
                <a:rPr lang="en-AU" sz="1020" dirty="0"/>
                <a:t>Manhattan plots of genome-wide association study (GWAS) using 38,948 SNPs markers for alkaloid status, flowering time and flower colour on 231 wild and domesticated narrow-leafed lupin accessions. The X-axis represents physical distance (Kb) along the 20 narrow-leafed lupin chromosomes, NLL-01 to NLL-20. SNPs above the threshold line (green line; -log10(p)=6) are significantly associated with related traits</a:t>
              </a:r>
              <a:endParaRPr lang="en-AU" sz="102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" name="Straight Connector 2"/>
            <p:cNvCxnSpPr/>
            <p:nvPr/>
          </p:nvCxnSpPr>
          <p:spPr>
            <a:xfrm>
              <a:off x="684904" y="158438"/>
              <a:ext cx="17442" cy="7084565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Straight Connector 66"/>
            <p:cNvCxnSpPr/>
            <p:nvPr/>
          </p:nvCxnSpPr>
          <p:spPr>
            <a:xfrm>
              <a:off x="4964812" y="227460"/>
              <a:ext cx="462" cy="691677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8" name="Group 17"/>
            <p:cNvGrpSpPr/>
            <p:nvPr/>
          </p:nvGrpSpPr>
          <p:grpSpPr>
            <a:xfrm>
              <a:off x="735999" y="436037"/>
              <a:ext cx="4228812" cy="5838642"/>
              <a:chOff x="611077" y="512792"/>
              <a:chExt cx="4973198" cy="6866402"/>
            </a:xfrm>
          </p:grpSpPr>
          <p:grpSp>
            <p:nvGrpSpPr>
              <p:cNvPr id="12" name="Group 11"/>
              <p:cNvGrpSpPr/>
              <p:nvPr/>
            </p:nvGrpSpPr>
            <p:grpSpPr>
              <a:xfrm>
                <a:off x="611077" y="512792"/>
                <a:ext cx="4973198" cy="2102817"/>
                <a:chOff x="611077" y="512792"/>
                <a:chExt cx="4973198" cy="2102817"/>
              </a:xfrm>
            </p:grpSpPr>
            <p:pic>
              <p:nvPicPr>
                <p:cNvPr id="9" name="Picture 8"/>
                <p:cNvPicPr>
                  <a:picLocks noChangeAspect="1"/>
                </p:cNvPicPr>
                <p:nvPr/>
              </p:nvPicPr>
              <p:blipFill rotWithShape="1"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12702"/>
                <a:stretch/>
              </p:blipFill>
              <p:spPr>
                <a:xfrm>
                  <a:off x="611077" y="695325"/>
                  <a:ext cx="4973198" cy="1920284"/>
                </a:xfrm>
                <a:prstGeom prst="rect">
                  <a:avLst/>
                </a:prstGeom>
              </p:spPr>
            </p:pic>
            <p:sp>
              <p:nvSpPr>
                <p:cNvPr id="10" name="TextBox 9"/>
                <p:cNvSpPr txBox="1"/>
                <p:nvPr/>
              </p:nvSpPr>
              <p:spPr>
                <a:xfrm>
                  <a:off x="2776915" y="512792"/>
                  <a:ext cx="692237" cy="27780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935" b="1" dirty="0"/>
                    <a:t>Alkaloid</a:t>
                  </a:r>
                </a:p>
              </p:txBody>
            </p:sp>
          </p:grpSp>
          <p:grpSp>
            <p:nvGrpSpPr>
              <p:cNvPr id="15" name="Group 14"/>
              <p:cNvGrpSpPr/>
              <p:nvPr/>
            </p:nvGrpSpPr>
            <p:grpSpPr>
              <a:xfrm>
                <a:off x="611077" y="2770491"/>
                <a:ext cx="4973198" cy="2146994"/>
                <a:chOff x="611077" y="2770491"/>
                <a:chExt cx="4973198" cy="2146994"/>
              </a:xfrm>
            </p:grpSpPr>
            <p:pic>
              <p:nvPicPr>
                <p:cNvPr id="11" name="Picture 10"/>
                <p:cNvPicPr>
                  <a:picLocks noChangeAspect="1"/>
                </p:cNvPicPr>
                <p:nvPr/>
              </p:nvPicPr>
              <p:blipFill rotWithShape="1"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12943"/>
                <a:stretch/>
              </p:blipFill>
              <p:spPr>
                <a:xfrm>
                  <a:off x="611077" y="3002507"/>
                  <a:ext cx="4973198" cy="1914978"/>
                </a:xfrm>
                <a:prstGeom prst="rect">
                  <a:avLst/>
                </a:prstGeom>
              </p:spPr>
            </p:pic>
            <p:sp>
              <p:nvSpPr>
                <p:cNvPr id="14" name="TextBox 13"/>
                <p:cNvSpPr txBox="1"/>
                <p:nvPr/>
              </p:nvSpPr>
              <p:spPr>
                <a:xfrm>
                  <a:off x="2770501" y="2770491"/>
                  <a:ext cx="1095663" cy="27780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935" b="1" dirty="0"/>
                    <a:t>Flowering time</a:t>
                  </a:r>
                </a:p>
              </p:txBody>
            </p:sp>
          </p:grpSp>
          <p:grpSp>
            <p:nvGrpSpPr>
              <p:cNvPr id="17" name="Group 16"/>
              <p:cNvGrpSpPr/>
              <p:nvPr/>
            </p:nvGrpSpPr>
            <p:grpSpPr>
              <a:xfrm>
                <a:off x="611077" y="5227087"/>
                <a:ext cx="4973198" cy="2152107"/>
                <a:chOff x="611077" y="5227087"/>
                <a:chExt cx="4973198" cy="2152107"/>
              </a:xfrm>
            </p:grpSpPr>
            <p:pic>
              <p:nvPicPr>
                <p:cNvPr id="13" name="Picture 12"/>
                <p:cNvPicPr>
                  <a:picLocks noChangeAspect="1"/>
                </p:cNvPicPr>
                <p:nvPr/>
              </p:nvPicPr>
              <p:blipFill rotWithShape="1"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13331"/>
                <a:stretch/>
              </p:blipFill>
              <p:spPr>
                <a:xfrm>
                  <a:off x="611077" y="5472751"/>
                  <a:ext cx="4973198" cy="1906443"/>
                </a:xfrm>
                <a:prstGeom prst="rect">
                  <a:avLst/>
                </a:prstGeom>
              </p:spPr>
            </p:pic>
            <p:sp>
              <p:nvSpPr>
                <p:cNvPr id="16" name="TextBox 15"/>
                <p:cNvSpPr txBox="1"/>
                <p:nvPr/>
              </p:nvSpPr>
              <p:spPr>
                <a:xfrm>
                  <a:off x="2788049" y="5227087"/>
                  <a:ext cx="1020257" cy="27780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935" b="1" dirty="0"/>
                    <a:t>Flower colour</a:t>
                  </a: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26166499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85</TotalTime>
  <Words>78</Words>
  <Application>Microsoft Office PowerPoint</Application>
  <PresentationFormat>Custom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hsa Mousaviderazmahalleh</dc:creator>
  <cp:lastModifiedBy>Mahsa Mousaviderazmahalleh</cp:lastModifiedBy>
  <cp:revision>43</cp:revision>
  <dcterms:created xsi:type="dcterms:W3CDTF">2016-11-04T04:41:02Z</dcterms:created>
  <dcterms:modified xsi:type="dcterms:W3CDTF">2018-09-15T09:04:35Z</dcterms:modified>
</cp:coreProperties>
</file>